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81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51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E4D2"/>
    <a:srgbClr val="B8D8BE"/>
    <a:srgbClr val="5AA668"/>
    <a:srgbClr val="6FB17C"/>
    <a:srgbClr val="8DC197"/>
    <a:srgbClr val="0AA63A"/>
    <a:srgbClr val="663C30"/>
    <a:srgbClr val="E9D5CF"/>
    <a:srgbClr val="E3CAC3"/>
    <a:srgbClr val="D9A6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2395" autoAdjust="0"/>
  </p:normalViewPr>
  <p:slideViewPr>
    <p:cSldViewPr snapToGrid="0" showGuides="1">
      <p:cViewPr varScale="1">
        <p:scale>
          <a:sx n="42" d="100"/>
          <a:sy n="42" d="100"/>
        </p:scale>
        <p:origin x="2544" y="66"/>
      </p:cViewPr>
      <p:guideLst>
        <p:guide orient="horz" pos="1351"/>
        <p:guide pos="206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8213584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8267" y="3856119"/>
            <a:ext cx="57541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|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supervised analysis of metabolic fingerprints of soil samples from the Atacama Desert</a:t>
            </a:r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mponent analysis exploring the variance between species*elevation conditions (4,366 features).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.imb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riplex imbricat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.sp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esmi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inosissim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.doe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ffmannseggi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elli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.fri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rav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igid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840F5E4-4C4D-FFCD-AD22-963C85AD8FCD}"/>
              </a:ext>
            </a:extLst>
          </p:cNvPr>
          <p:cNvSpPr/>
          <p:nvPr/>
        </p:nvSpPr>
        <p:spPr>
          <a:xfrm>
            <a:off x="545550" y="532867"/>
            <a:ext cx="5760000" cy="3254273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4F13B97E-200E-814E-5465-B90E54DB0AB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225" y="592206"/>
            <a:ext cx="3240000" cy="31355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5242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06</TotalTime>
  <Words>61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Times New Roman</vt:lpstr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690</cp:revision>
  <dcterms:created xsi:type="dcterms:W3CDTF">2020-07-29T08:33:47Z</dcterms:created>
  <dcterms:modified xsi:type="dcterms:W3CDTF">2023-10-13T13:58:12Z</dcterms:modified>
</cp:coreProperties>
</file>